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724650" cy="97742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79" userDrawn="1">
          <p15:clr>
            <a:srgbClr val="A4A3A4"/>
          </p15:clr>
        </p15:guide>
        <p15:guide id="2" pos="1678" userDrawn="1">
          <p15:clr>
            <a:srgbClr val="A4A3A4"/>
          </p15:clr>
        </p15:guide>
        <p15:guide id="3" orient="horz" pos="1230" userDrawn="1">
          <p15:clr>
            <a:srgbClr val="A4A3A4"/>
          </p15:clr>
        </p15:guide>
        <p15:guide id="4" orient="horz" pos="2795" userDrawn="1">
          <p15:clr>
            <a:srgbClr val="A4A3A4"/>
          </p15:clr>
        </p15:guide>
        <p15:guide id="6" pos="295" userDrawn="1">
          <p15:clr>
            <a:srgbClr val="A4A3A4"/>
          </p15:clr>
        </p15:guide>
        <p15:guide id="7" pos="3107" userDrawn="1">
          <p15:clr>
            <a:srgbClr val="A4A3A4"/>
          </p15:clr>
        </p15:guide>
        <p15:guide id="8" pos="4468" userDrawn="1">
          <p15:clr>
            <a:srgbClr val="A4A3A4"/>
          </p15:clr>
        </p15:guide>
        <p15:guide id="9" pos="278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602" y="96"/>
      </p:cViewPr>
      <p:guideLst>
        <p:guide orient="horz" pos="1979"/>
        <p:guide pos="1678"/>
        <p:guide orient="horz" pos="1230"/>
        <p:guide orient="horz" pos="2795"/>
        <p:guide pos="295"/>
        <p:guide pos="3107"/>
        <p:guide pos="4468"/>
        <p:guide pos="278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6163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3247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550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0682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288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1580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2082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8384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5835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2444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1335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1609E-2170-4CD2-BA36-25EB3262D100}" type="datetimeFigureOut">
              <a:rPr lang="de-DE" smtClean="0"/>
              <a:t>27.08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F5224-1EFF-42B3-847D-EFA9E8041BA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9931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k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6557263"/>
              </p:ext>
            </p:extLst>
          </p:nvPr>
        </p:nvGraphicFramePr>
        <p:xfrm>
          <a:off x="20481" y="436065"/>
          <a:ext cx="2200276" cy="2335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4" name="Prism Project" r:id="rId3" imgW="3528000" imgH="3276000" progId="Prism5.Document">
                  <p:embed/>
                </p:oleObj>
              </mc:Choice>
              <mc:Fallback>
                <p:oleObj name="Prism Project" r:id="rId3" imgW="3528000" imgH="3276000" progId="Prism5.Document">
                  <p:embed/>
                  <p:pic>
                    <p:nvPicPr>
                      <p:cNvPr id="15" name="Objekt 14"/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481" y="436065"/>
                        <a:ext cx="2200276" cy="2335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0222493"/>
              </p:ext>
            </p:extLst>
          </p:nvPr>
        </p:nvGraphicFramePr>
        <p:xfrm>
          <a:off x="2226364" y="2940050"/>
          <a:ext cx="2246312" cy="225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5" name="Prism Project" r:id="rId5" imgW="3492000" imgH="3420000" progId="Prism5.Document">
                  <p:embed/>
                </p:oleObj>
              </mc:Choice>
              <mc:Fallback>
                <p:oleObj name="Prism Project" r:id="rId5" imgW="3492000" imgH="3420000" progId="Prism5.Document">
                  <p:embed/>
                  <p:pic>
                    <p:nvPicPr>
                      <p:cNvPr id="19" name="Objekt 18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26364" y="2940050"/>
                        <a:ext cx="2246312" cy="225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feld 19"/>
          <p:cNvSpPr txBox="1"/>
          <p:nvPr/>
        </p:nvSpPr>
        <p:spPr>
          <a:xfrm>
            <a:off x="258350" y="343092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a</a:t>
            </a:r>
            <a:endParaRPr lang="de-DE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2473264" y="35223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4677682" y="332656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c</a:t>
            </a:r>
            <a:endParaRPr lang="de-DE" b="1" dirty="0"/>
          </a:p>
        </p:txBody>
      </p:sp>
      <p:sp>
        <p:nvSpPr>
          <p:cNvPr id="23" name="Textfeld 22"/>
          <p:cNvSpPr txBox="1"/>
          <p:nvPr/>
        </p:nvSpPr>
        <p:spPr>
          <a:xfrm>
            <a:off x="6904922" y="34294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d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265479" y="27814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e</a:t>
            </a:r>
            <a:endParaRPr lang="de-DE" b="1" dirty="0"/>
          </a:p>
        </p:txBody>
      </p:sp>
      <p:sp>
        <p:nvSpPr>
          <p:cNvPr id="25" name="Textfeld 24"/>
          <p:cNvSpPr txBox="1"/>
          <p:nvPr/>
        </p:nvSpPr>
        <p:spPr>
          <a:xfrm>
            <a:off x="2457480" y="2771278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</a:t>
            </a:r>
            <a:endParaRPr lang="de-DE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4669819" y="2771278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g</a:t>
            </a:r>
            <a:endParaRPr lang="de-DE" b="1" dirty="0"/>
          </a:p>
        </p:txBody>
      </p:sp>
      <p:sp>
        <p:nvSpPr>
          <p:cNvPr id="27" name="Textfeld 26"/>
          <p:cNvSpPr txBox="1"/>
          <p:nvPr/>
        </p:nvSpPr>
        <p:spPr>
          <a:xfrm>
            <a:off x="6905756" y="277265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h</a:t>
            </a:r>
            <a:endParaRPr lang="de-DE" b="1" dirty="0"/>
          </a:p>
        </p:txBody>
      </p:sp>
      <p:graphicFrame>
        <p:nvGraphicFramePr>
          <p:cNvPr id="30" name="Objek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4398160"/>
              </p:ext>
            </p:extLst>
          </p:nvPr>
        </p:nvGraphicFramePr>
        <p:xfrm>
          <a:off x="4521200" y="451502"/>
          <a:ext cx="2178050" cy="2335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6" name="Prism Project" r:id="rId7" imgW="3492000" imgH="3276000" progId="Prism5.Document">
                  <p:embed/>
                </p:oleObj>
              </mc:Choice>
              <mc:Fallback>
                <p:oleObj name="Prism Project" r:id="rId7" imgW="3492000" imgH="3276000" progId="Prism5.Document">
                  <p:embed/>
                  <p:pic>
                    <p:nvPicPr>
                      <p:cNvPr id="15" name="Objekt 14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21200" y="451502"/>
                        <a:ext cx="2178050" cy="2335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4447390"/>
              </p:ext>
            </p:extLst>
          </p:nvPr>
        </p:nvGraphicFramePr>
        <p:xfrm>
          <a:off x="6686550" y="425451"/>
          <a:ext cx="2155825" cy="2335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7" name="Prism Project" r:id="rId9" imgW="3456000" imgH="3276000" progId="Prism5.Document">
                  <p:embed/>
                </p:oleObj>
              </mc:Choice>
              <mc:Fallback>
                <p:oleObj name="Prism Project" r:id="rId9" imgW="3456000" imgH="3276000" progId="Prism5.Document">
                  <p:embed/>
                  <p:pic>
                    <p:nvPicPr>
                      <p:cNvPr id="30" name="Objekt 29"/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686550" y="425451"/>
                        <a:ext cx="2155825" cy="2335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k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1711813"/>
              </p:ext>
            </p:extLst>
          </p:nvPr>
        </p:nvGraphicFramePr>
        <p:xfrm>
          <a:off x="46038" y="2907505"/>
          <a:ext cx="2178050" cy="2335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8" name="Prism Project" r:id="rId11" imgW="3492000" imgH="3276000" progId="Prism5.Document">
                  <p:embed/>
                </p:oleObj>
              </mc:Choice>
              <mc:Fallback>
                <p:oleObj name="Prism Project" r:id="rId11" imgW="3492000" imgH="3276000" progId="Prism5.Document">
                  <p:embed/>
                  <p:pic>
                    <p:nvPicPr>
                      <p:cNvPr id="31" name="Objekt 30"/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6038" y="2907505"/>
                        <a:ext cx="2178050" cy="2335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k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8726694"/>
              </p:ext>
            </p:extLst>
          </p:nvPr>
        </p:nvGraphicFramePr>
        <p:xfrm>
          <a:off x="6686550" y="2918407"/>
          <a:ext cx="2178050" cy="2335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9" name="Prism Project" r:id="rId13" imgW="3492000" imgH="3276000" progId="Prism5.Document">
                  <p:embed/>
                </p:oleObj>
              </mc:Choice>
              <mc:Fallback>
                <p:oleObj name="Prism Project" r:id="rId13" imgW="3492000" imgH="3276000" progId="Prism5.Document">
                  <p:embed/>
                  <p:pic>
                    <p:nvPicPr>
                      <p:cNvPr id="15" name="Objekt 14"/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686550" y="2918407"/>
                        <a:ext cx="2178050" cy="2335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k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7745042"/>
              </p:ext>
            </p:extLst>
          </p:nvPr>
        </p:nvGraphicFramePr>
        <p:xfrm>
          <a:off x="4521200" y="2946400"/>
          <a:ext cx="2224088" cy="225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0" name="Prism Project" r:id="rId15" imgW="3456000" imgH="3420000" progId="Prism5.Document">
                  <p:embed/>
                </p:oleObj>
              </mc:Choice>
              <mc:Fallback>
                <p:oleObj name="Prism Project" r:id="rId15" imgW="3456000" imgH="3420000" progId="Prism5.Document">
                  <p:embed/>
                  <p:pic>
                    <p:nvPicPr>
                      <p:cNvPr id="19" name="Objekt 18"/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521200" y="2946400"/>
                        <a:ext cx="2224088" cy="225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k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7071591"/>
              </p:ext>
            </p:extLst>
          </p:nvPr>
        </p:nvGraphicFramePr>
        <p:xfrm>
          <a:off x="2234406" y="451502"/>
          <a:ext cx="2247900" cy="225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1" name="Prism Project" r:id="rId17" imgW="3492000" imgH="3420000" progId="Prism5.Document">
                  <p:embed/>
                </p:oleObj>
              </mc:Choice>
              <mc:Fallback>
                <p:oleObj name="Prism Project" r:id="rId17" imgW="3492000" imgH="3420000" progId="Prism5.Document">
                  <p:embed/>
                  <p:pic>
                    <p:nvPicPr>
                      <p:cNvPr id="34" name="Objekt 33"/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234406" y="451502"/>
                        <a:ext cx="2247900" cy="225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376135" y="5363511"/>
            <a:ext cx="8457010" cy="10926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, weight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organs, visceral fat and uterus 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nd of the 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OVX rats either untreated or treated with ostarine (OST), raloxifene (RAL) or combined treatment (OST+RAL) and NON-OVX 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ts. </a:t>
            </a:r>
          </a:p>
          <a:p>
            <a:pPr algn="just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 Values are shown as BW adjusted least-squares means with SE where BW was a significant covariate; all other values are presented as means with SD. 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s from all other groups, </a:t>
            </a:r>
            <a:r>
              <a:rPr lang="en-U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ffers vs. NON-OVX, </a:t>
            </a:r>
            <a:r>
              <a:rPr lang="en-U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OVX, </a:t>
            </a:r>
            <a:r>
              <a:rPr lang="en-U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OST, </a:t>
            </a:r>
            <a:r>
              <a:rPr lang="en-U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RAL, </a:t>
            </a:r>
            <a:r>
              <a:rPr lang="en-US" sz="13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OST+RAL (p &lt; 0.05, </a:t>
            </a:r>
            <a:r>
              <a:rPr lang="en-US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ukey test). 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data were published in </a:t>
            </a:r>
            <a:r>
              <a:rPr lang="en-GB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ch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 </a:t>
            </a:r>
            <a:r>
              <a:rPr lang="en-GB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14]</a:t>
            </a:r>
            <a:r>
              <a:rPr lang="en-GB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6940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5</Words>
  <Application>Microsoft Office PowerPoint</Application>
  <PresentationFormat>Bildschirmpräsentation (4:3)</PresentationFormat>
  <Paragraphs>10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rism Project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na Komrakova</dc:creator>
  <cp:lastModifiedBy>Komrakova, Marina</cp:lastModifiedBy>
  <cp:revision>59</cp:revision>
  <cp:lastPrinted>2025-08-25T13:29:09Z</cp:lastPrinted>
  <dcterms:created xsi:type="dcterms:W3CDTF">2024-04-26T08:22:05Z</dcterms:created>
  <dcterms:modified xsi:type="dcterms:W3CDTF">2025-08-27T07:56:22Z</dcterms:modified>
</cp:coreProperties>
</file>